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-72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Soham\Desktop\5th yr project\Phylogenetic Tree\Post MSA grouping\168\168 class1Jukes Cantor mode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725468"/>
            <a:ext cx="3733800" cy="5446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362200" y="152401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3276600" y="725463"/>
            <a:ext cx="0" cy="25146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6200" y="3448832"/>
            <a:ext cx="0" cy="6294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4800600" y="4840264"/>
            <a:ext cx="0" cy="1066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233468" y="1639873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Dicots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840195" y="3625058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/>
              <a:t>Solanaceae</a:t>
            </a:r>
            <a:endParaRPr lang="en-US" sz="1200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4748845" y="5249553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nocots</a:t>
            </a:r>
            <a:endParaRPr lang="en-US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685800" y="6553200"/>
            <a:ext cx="5791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.  </a:t>
            </a:r>
            <a:r>
              <a:rPr lang="en-US" sz="1200" dirty="0"/>
              <a:t>Phylogenetic analysis of precursors of miR168. Tree was constructed using MEGA 6.0 software with Neighbor Joining Method with 1000 bootstrapping replications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437867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8</TotalTime>
  <Words>30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9</cp:revision>
  <dcterms:created xsi:type="dcterms:W3CDTF">2006-08-16T00:00:00Z</dcterms:created>
  <dcterms:modified xsi:type="dcterms:W3CDTF">2014-08-25T07:00:48Z</dcterms:modified>
</cp:coreProperties>
</file>